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86" d="100"/>
          <a:sy n="86" d="100"/>
        </p:scale>
        <p:origin x="-35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zhang8:Documents:Papers,%20Review%20comments%20and%20Invention%20Disclosure:Comparison%20of%20autoclaved%20and%20non-autoclaved%20methods%20(3-2015)%20:Data:ZM%20in%202012-ACSH%20and%202010-ASGH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yzhang8:Documents:Papers,%20Review%20comments%20and%20Invention%20Disclosure:Comparison%20of%20autoclaved%20and%20non-autoclaved%20methods%20(3-2015)%20:Data:ZM%20in%202012-ACSH%20and%202010-ASGH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8198812706679"/>
          <c:y val="0.105052971729745"/>
          <c:w val="0.763049411867159"/>
          <c:h val="0.70053054087293"/>
        </c:manualLayout>
      </c:layout>
      <c:scatterChart>
        <c:scatterStyle val="lineMarker"/>
        <c:varyColors val="0"/>
        <c:ser>
          <c:idx val="2"/>
          <c:order val="1"/>
          <c:tx>
            <c:strRef>
              <c:f>'Zm in NAC-2010-ASGH'!$F$1</c:f>
              <c:strCache>
                <c:ptCount val="1"/>
                <c:pt idx="0">
                  <c:v>NAC-ASGH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circl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0-ASGH'!$G$2:$G$15</c:f>
                <c:numCache>
                  <c:formatCode>General</c:formatCode>
                  <c:ptCount val="14"/>
                  <c:pt idx="0">
                    <c:v>0.0152752523165194</c:v>
                  </c:pt>
                  <c:pt idx="1">
                    <c:v>0.0896288643983251</c:v>
                  </c:pt>
                  <c:pt idx="2">
                    <c:v>0.111504857891185</c:v>
                  </c:pt>
                  <c:pt idx="3">
                    <c:v>0.266333124739176</c:v>
                  </c:pt>
                  <c:pt idx="4">
                    <c:v>0.275378527364305</c:v>
                  </c:pt>
                  <c:pt idx="5">
                    <c:v>0.343693177121688</c:v>
                  </c:pt>
                  <c:pt idx="6">
                    <c:v>0.505181485540923</c:v>
                  </c:pt>
                  <c:pt idx="7">
                    <c:v>0.283945417290014</c:v>
                  </c:pt>
                  <c:pt idx="8">
                    <c:v>0.283945417290014</c:v>
                  </c:pt>
                  <c:pt idx="9">
                    <c:v>0.423034671549902</c:v>
                  </c:pt>
                  <c:pt idx="10">
                    <c:v>0.415581921326389</c:v>
                  </c:pt>
                  <c:pt idx="11">
                    <c:v>0.414075274960162</c:v>
                  </c:pt>
                  <c:pt idx="12">
                    <c:v>0.425979263971068</c:v>
                  </c:pt>
                  <c:pt idx="13">
                    <c:v>0.332916405923969</c:v>
                  </c:pt>
                </c:numCache>
              </c:numRef>
            </c:plus>
            <c:minus>
              <c:numRef>
                <c:f>'Zm in NAC-2010-ASGH'!$G$2:$G$15</c:f>
                <c:numCache>
                  <c:formatCode>General</c:formatCode>
                  <c:ptCount val="14"/>
                  <c:pt idx="0">
                    <c:v>0.0152752523165194</c:v>
                  </c:pt>
                  <c:pt idx="1">
                    <c:v>0.0896288643983251</c:v>
                  </c:pt>
                  <c:pt idx="2">
                    <c:v>0.111504857891185</c:v>
                  </c:pt>
                  <c:pt idx="3">
                    <c:v>0.266333124739176</c:v>
                  </c:pt>
                  <c:pt idx="4">
                    <c:v>0.275378527364305</c:v>
                  </c:pt>
                  <c:pt idx="5">
                    <c:v>0.343693177121688</c:v>
                  </c:pt>
                  <c:pt idx="6">
                    <c:v>0.505181485540923</c:v>
                  </c:pt>
                  <c:pt idx="7">
                    <c:v>0.283945417290014</c:v>
                  </c:pt>
                  <c:pt idx="8">
                    <c:v>0.283945417290014</c:v>
                  </c:pt>
                  <c:pt idx="9">
                    <c:v>0.423034671549902</c:v>
                  </c:pt>
                  <c:pt idx="10">
                    <c:v>0.415581921326389</c:v>
                  </c:pt>
                  <c:pt idx="11">
                    <c:v>0.414075274960162</c:v>
                  </c:pt>
                  <c:pt idx="12">
                    <c:v>0.425979263971068</c:v>
                  </c:pt>
                  <c:pt idx="13">
                    <c:v>0.332916405923969</c:v>
                  </c:pt>
                </c:numCache>
              </c:numRef>
            </c:minus>
          </c:errBars>
          <c:xVal>
            <c:numRef>
              <c:f>'Zm in NAC-2010-ASGH'!$B$2:$B$15</c:f>
              <c:numCache>
                <c:formatCode>0.0</c:formatCode>
                <c:ptCount val="14"/>
                <c:pt idx="0">
                  <c:v>0.0</c:v>
                </c:pt>
                <c:pt idx="1">
                  <c:v>3.333333333333333</c:v>
                </c:pt>
                <c:pt idx="2">
                  <c:v>5.333333333333332</c:v>
                </c:pt>
                <c:pt idx="3">
                  <c:v>8.333333333333332</c:v>
                </c:pt>
                <c:pt idx="4">
                  <c:v>10.83333333333333</c:v>
                </c:pt>
                <c:pt idx="5">
                  <c:v>13.0</c:v>
                </c:pt>
                <c:pt idx="6">
                  <c:v>15.83333333333333</c:v>
                </c:pt>
                <c:pt idx="7">
                  <c:v>17.83333333333328</c:v>
                </c:pt>
                <c:pt idx="8">
                  <c:v>21.33333333333329</c:v>
                </c:pt>
                <c:pt idx="9">
                  <c:v>23.33333333333329</c:v>
                </c:pt>
                <c:pt idx="10">
                  <c:v>30.33333333333329</c:v>
                </c:pt>
                <c:pt idx="11">
                  <c:v>33.33333333333333</c:v>
                </c:pt>
                <c:pt idx="12">
                  <c:v>38.83333333333334</c:v>
                </c:pt>
                <c:pt idx="13">
                  <c:v>43.66666666666659</c:v>
                </c:pt>
              </c:numCache>
            </c:numRef>
          </c:xVal>
          <c:yVal>
            <c:numRef>
              <c:f>'Zm in NAC-2010-ASGH'!$F$2:$F$15</c:f>
              <c:numCache>
                <c:formatCode>0.00</c:formatCode>
                <c:ptCount val="14"/>
                <c:pt idx="0">
                  <c:v>0.586666666666667</c:v>
                </c:pt>
                <c:pt idx="1">
                  <c:v>0.906666666666667</c:v>
                </c:pt>
                <c:pt idx="2">
                  <c:v>1.303333333333333</c:v>
                </c:pt>
                <c:pt idx="3">
                  <c:v>2.453333333333334</c:v>
                </c:pt>
                <c:pt idx="4">
                  <c:v>4.258333333333332</c:v>
                </c:pt>
                <c:pt idx="5">
                  <c:v>5.55</c:v>
                </c:pt>
                <c:pt idx="6">
                  <c:v>5.583333333333333</c:v>
                </c:pt>
                <c:pt idx="7">
                  <c:v>5.599999999999999</c:v>
                </c:pt>
                <c:pt idx="8">
                  <c:v>5.599999999999999</c:v>
                </c:pt>
                <c:pt idx="9">
                  <c:v>5.608333333333333</c:v>
                </c:pt>
                <c:pt idx="10">
                  <c:v>5.616666666666667</c:v>
                </c:pt>
                <c:pt idx="11">
                  <c:v>5.808333333333333</c:v>
                </c:pt>
                <c:pt idx="12">
                  <c:v>5.741666666666667</c:v>
                </c:pt>
                <c:pt idx="13">
                  <c:v>5.266666666666666</c:v>
                </c:pt>
              </c:numCache>
            </c:numRef>
          </c:yVal>
          <c:smooth val="0"/>
        </c:ser>
        <c:ser>
          <c:idx val="0"/>
          <c:order val="0"/>
          <c:tx>
            <c:strRef>
              <c:f>'Zm in NAC-2012-ACSH'!$F$1</c:f>
              <c:strCache>
                <c:ptCount val="1"/>
                <c:pt idx="0">
                  <c:v>NAC-ACSH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2-ACSH'!$G$2:$G$15</c:f>
                <c:numCache>
                  <c:formatCode>General</c:formatCode>
                  <c:ptCount val="14"/>
                  <c:pt idx="0">
                    <c:v>0.0321455025366432</c:v>
                  </c:pt>
                  <c:pt idx="1">
                    <c:v>0.0404145188432739</c:v>
                  </c:pt>
                  <c:pt idx="2">
                    <c:v>0.0550757054728611</c:v>
                  </c:pt>
                  <c:pt idx="3">
                    <c:v>0.101159939369957</c:v>
                  </c:pt>
                  <c:pt idx="4">
                    <c:v>0.0750555349946513</c:v>
                  </c:pt>
                  <c:pt idx="5">
                    <c:v>0.118145390656315</c:v>
                  </c:pt>
                  <c:pt idx="6">
                    <c:v>0.118145390656316</c:v>
                  </c:pt>
                  <c:pt idx="7">
                    <c:v>0.382698750106835</c:v>
                  </c:pt>
                  <c:pt idx="8">
                    <c:v>0.447446458621959</c:v>
                  </c:pt>
                  <c:pt idx="9">
                    <c:v>0.177364972114939</c:v>
                  </c:pt>
                  <c:pt idx="10">
                    <c:v>0.246221445044903</c:v>
                  </c:pt>
                  <c:pt idx="11">
                    <c:v>0.275378527364305</c:v>
                  </c:pt>
                  <c:pt idx="12">
                    <c:v>0.526980391792079</c:v>
                  </c:pt>
                  <c:pt idx="13">
                    <c:v>0.246644143115812</c:v>
                  </c:pt>
                </c:numCache>
              </c:numRef>
            </c:plus>
            <c:minus>
              <c:numRef>
                <c:f>'Zm in NAC-2012-ACSH'!$G$2:$G$15</c:f>
                <c:numCache>
                  <c:formatCode>General</c:formatCode>
                  <c:ptCount val="14"/>
                  <c:pt idx="0">
                    <c:v>0.0321455025366432</c:v>
                  </c:pt>
                  <c:pt idx="1">
                    <c:v>0.0404145188432739</c:v>
                  </c:pt>
                  <c:pt idx="2">
                    <c:v>0.0550757054728611</c:v>
                  </c:pt>
                  <c:pt idx="3">
                    <c:v>0.101159939369957</c:v>
                  </c:pt>
                  <c:pt idx="4">
                    <c:v>0.0750555349946513</c:v>
                  </c:pt>
                  <c:pt idx="5">
                    <c:v>0.118145390656315</c:v>
                  </c:pt>
                  <c:pt idx="6">
                    <c:v>0.118145390656316</c:v>
                  </c:pt>
                  <c:pt idx="7">
                    <c:v>0.382698750106835</c:v>
                  </c:pt>
                  <c:pt idx="8">
                    <c:v>0.447446458621959</c:v>
                  </c:pt>
                  <c:pt idx="9">
                    <c:v>0.177364972114939</c:v>
                  </c:pt>
                  <c:pt idx="10">
                    <c:v>0.246221445044903</c:v>
                  </c:pt>
                  <c:pt idx="11">
                    <c:v>0.275378527364305</c:v>
                  </c:pt>
                  <c:pt idx="12">
                    <c:v>0.526980391792079</c:v>
                  </c:pt>
                  <c:pt idx="13">
                    <c:v>0.246644143115812</c:v>
                  </c:pt>
                </c:numCache>
              </c:numRef>
            </c:minus>
          </c:errBars>
          <c:xVal>
            <c:numRef>
              <c:f>'Zm in NAC-2012-ACSH'!$B$2:$B$15</c:f>
              <c:numCache>
                <c:formatCode>0.0</c:formatCode>
                <c:ptCount val="14"/>
                <c:pt idx="0">
                  <c:v>0.0</c:v>
                </c:pt>
                <c:pt idx="1">
                  <c:v>1.999999999999998</c:v>
                </c:pt>
                <c:pt idx="2">
                  <c:v>3.999999999999999</c:v>
                </c:pt>
                <c:pt idx="3">
                  <c:v>6.0</c:v>
                </c:pt>
                <c:pt idx="4">
                  <c:v>7.999999999999998</c:v>
                </c:pt>
                <c:pt idx="5">
                  <c:v>10.0</c:v>
                </c:pt>
                <c:pt idx="6">
                  <c:v>10.5</c:v>
                </c:pt>
                <c:pt idx="7">
                  <c:v>13.0</c:v>
                </c:pt>
                <c:pt idx="8">
                  <c:v>16.0</c:v>
                </c:pt>
                <c:pt idx="9">
                  <c:v>18.0</c:v>
                </c:pt>
                <c:pt idx="10">
                  <c:v>20.66666666666667</c:v>
                </c:pt>
                <c:pt idx="11">
                  <c:v>26.0</c:v>
                </c:pt>
                <c:pt idx="12">
                  <c:v>34.41666666666658</c:v>
                </c:pt>
                <c:pt idx="13">
                  <c:v>40.0</c:v>
                </c:pt>
              </c:numCache>
            </c:numRef>
          </c:xVal>
          <c:yVal>
            <c:numRef>
              <c:f>'Zm in NAC-2012-ACSH'!$F$2:$F$15</c:f>
              <c:numCache>
                <c:formatCode>0.00</c:formatCode>
                <c:ptCount val="14"/>
                <c:pt idx="0">
                  <c:v>0.656666666666667</c:v>
                </c:pt>
                <c:pt idx="1">
                  <c:v>0.783333333333333</c:v>
                </c:pt>
                <c:pt idx="2">
                  <c:v>1.056666666666667</c:v>
                </c:pt>
                <c:pt idx="3">
                  <c:v>1.833333333333333</c:v>
                </c:pt>
                <c:pt idx="4">
                  <c:v>2.443333333333333</c:v>
                </c:pt>
                <c:pt idx="5">
                  <c:v>3.966666666666666</c:v>
                </c:pt>
                <c:pt idx="6">
                  <c:v>4.208333333333333</c:v>
                </c:pt>
                <c:pt idx="7">
                  <c:v>5.116666666666667</c:v>
                </c:pt>
                <c:pt idx="8">
                  <c:v>5.716666666666665</c:v>
                </c:pt>
                <c:pt idx="9">
                  <c:v>5.683333333333333</c:v>
                </c:pt>
                <c:pt idx="10">
                  <c:v>5.725</c:v>
                </c:pt>
                <c:pt idx="11">
                  <c:v>5.991666666666667</c:v>
                </c:pt>
                <c:pt idx="12">
                  <c:v>6.016666666666666</c:v>
                </c:pt>
                <c:pt idx="13">
                  <c:v>5.90833333333333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35820504"/>
        <c:axId val="2092644472"/>
      </c:scatterChart>
      <c:valAx>
        <c:axId val="-2035820504"/>
        <c:scaling>
          <c:orientation val="minMax"/>
          <c:max val="60.0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Time (h)</a:t>
                </a:r>
              </a:p>
            </c:rich>
          </c:tx>
          <c:layout>
            <c:manualLayout>
              <c:xMode val="edge"/>
              <c:yMode val="edge"/>
              <c:x val="0.446963818075216"/>
              <c:y val="0.897589117622371"/>
            </c:manualLayout>
          </c:layout>
          <c:overlay val="0"/>
        </c:title>
        <c:numFmt formatCode="0" sourceLinked="0"/>
        <c:majorTickMark val="out"/>
        <c:minorTickMark val="in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2092644472"/>
        <c:crossesAt val="0.1"/>
        <c:crossBetween val="midCat"/>
      </c:valAx>
      <c:valAx>
        <c:axId val="2092644472"/>
        <c:scaling>
          <c:logBase val="10.0"/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 dirty="0"/>
                  <a:t>OD</a:t>
                </a:r>
                <a:r>
                  <a:rPr lang="en-US" sz="1600" baseline="-25000" dirty="0"/>
                  <a:t>600</a:t>
                </a:r>
              </a:p>
            </c:rich>
          </c:tx>
          <c:layout>
            <c:manualLayout>
              <c:xMode val="edge"/>
              <c:yMode val="edge"/>
              <c:x val="0.00705994411988824"/>
              <c:y val="0.375785452561004"/>
            </c:manualLayout>
          </c:layout>
          <c:overlay val="0"/>
        </c:title>
        <c:numFmt formatCode="0" sourceLinked="0"/>
        <c:majorTickMark val="out"/>
        <c:minorTickMark val="in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-2035820504"/>
        <c:crosses val="autoZero"/>
        <c:crossBetween val="midCat"/>
      </c:valAx>
      <c:spPr>
        <a:noFill/>
        <a:ln w="25400">
          <a:solidFill>
            <a:srgbClr val="000000"/>
          </a:solidFill>
        </a:ln>
        <a:effectLst/>
      </c:spPr>
    </c:plotArea>
    <c:legend>
      <c:legendPos val="r"/>
      <c:layout>
        <c:manualLayout>
          <c:xMode val="edge"/>
          <c:yMode val="edge"/>
          <c:x val="0.525992806950536"/>
          <c:y val="0.488444009216275"/>
          <c:w val="0.32439171687082"/>
          <c:h val="0.226188772150812"/>
        </c:manualLayout>
      </c:layout>
      <c:overlay val="0"/>
      <c:spPr>
        <a:solidFill>
          <a:srgbClr val="FFFFFF"/>
        </a:solidFill>
        <a:ln w="9525" cap="flat" cmpd="sng" algn="ctr">
          <a:solidFill>
            <a:srgbClr val="000000"/>
          </a:solidFill>
          <a:prstDash val="solid"/>
        </a:ln>
        <a:effectLst/>
      </c:spPr>
      <c:txPr>
        <a:bodyPr/>
        <a:lstStyle/>
        <a:p>
          <a:pPr>
            <a:defRPr sz="1400">
              <a:solidFill>
                <a:schemeClr val="dk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solidFill>
        <a:srgbClr val="000000"/>
      </a:solidFill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9608117691986"/>
          <c:y val="0.103216153098973"/>
          <c:w val="0.666894829634167"/>
          <c:h val="0.689713147446731"/>
        </c:manualLayout>
      </c:layout>
      <c:scatterChart>
        <c:scatterStyle val="lineMarker"/>
        <c:varyColors val="0"/>
        <c:ser>
          <c:idx val="6"/>
          <c:order val="3"/>
          <c:tx>
            <c:strRef>
              <c:f>'Zm in NAC-2010-ASGH'!$L$22:$L$23</c:f>
              <c:strCache>
                <c:ptCount val="1"/>
                <c:pt idx="0">
                  <c:v>NAC-ASGH Glu (g/l)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circl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0-ASGH'!$Q$24:$Q$37</c:f>
                <c:numCache>
                  <c:formatCode>General</c:formatCode>
                  <c:ptCount val="14"/>
                  <c:pt idx="0">
                    <c:v>1.69</c:v>
                  </c:pt>
                  <c:pt idx="1">
                    <c:v>2.02</c:v>
                  </c:pt>
                  <c:pt idx="2">
                    <c:v>2.37</c:v>
                  </c:pt>
                  <c:pt idx="3">
                    <c:v>2.95</c:v>
                  </c:pt>
                  <c:pt idx="4">
                    <c:v>3.33</c:v>
                  </c:pt>
                  <c:pt idx="5">
                    <c:v>3.33</c:v>
                  </c:pt>
                  <c:pt idx="6">
                    <c:v>1.3</c:v>
                  </c:pt>
                  <c:pt idx="7">
                    <c:v>0.71</c:v>
                  </c:pt>
                  <c:pt idx="8">
                    <c:v>0.05</c:v>
                  </c:pt>
                  <c:pt idx="9">
                    <c:v>0.03</c:v>
                  </c:pt>
                  <c:pt idx="10">
                    <c:v>0.04</c:v>
                  </c:pt>
                  <c:pt idx="11">
                    <c:v>0.09</c:v>
                  </c:pt>
                  <c:pt idx="12">
                    <c:v>0.08</c:v>
                  </c:pt>
                  <c:pt idx="13">
                    <c:v>0.05</c:v>
                  </c:pt>
                </c:numCache>
              </c:numRef>
            </c:plus>
            <c:minus>
              <c:numRef>
                <c:f>'Zm in NAC-2010-ASGH'!$Q$24:$Q$37</c:f>
                <c:numCache>
                  <c:formatCode>General</c:formatCode>
                  <c:ptCount val="14"/>
                  <c:pt idx="0">
                    <c:v>1.69</c:v>
                  </c:pt>
                  <c:pt idx="1">
                    <c:v>2.02</c:v>
                  </c:pt>
                  <c:pt idx="2">
                    <c:v>2.37</c:v>
                  </c:pt>
                  <c:pt idx="3">
                    <c:v>2.95</c:v>
                  </c:pt>
                  <c:pt idx="4">
                    <c:v>3.33</c:v>
                  </c:pt>
                  <c:pt idx="5">
                    <c:v>3.33</c:v>
                  </c:pt>
                  <c:pt idx="6">
                    <c:v>1.3</c:v>
                  </c:pt>
                  <c:pt idx="7">
                    <c:v>0.71</c:v>
                  </c:pt>
                  <c:pt idx="8">
                    <c:v>0.05</c:v>
                  </c:pt>
                  <c:pt idx="9">
                    <c:v>0.03</c:v>
                  </c:pt>
                  <c:pt idx="10">
                    <c:v>0.04</c:v>
                  </c:pt>
                  <c:pt idx="11">
                    <c:v>0.09</c:v>
                  </c:pt>
                  <c:pt idx="12">
                    <c:v>0.08</c:v>
                  </c:pt>
                  <c:pt idx="13">
                    <c:v>0.05</c:v>
                  </c:pt>
                </c:numCache>
              </c:numRef>
            </c:minus>
          </c:errBars>
          <c:xVal>
            <c:numRef>
              <c:f>'Zm in NAC-2010-ASGH'!$B$24:$B$37</c:f>
              <c:numCache>
                <c:formatCode>0.0</c:formatCode>
                <c:ptCount val="14"/>
                <c:pt idx="0">
                  <c:v>0.0</c:v>
                </c:pt>
                <c:pt idx="1">
                  <c:v>3.333333333333333</c:v>
                </c:pt>
                <c:pt idx="2">
                  <c:v>5.333333333333332</c:v>
                </c:pt>
                <c:pt idx="3">
                  <c:v>8.333333333333332</c:v>
                </c:pt>
                <c:pt idx="4">
                  <c:v>10.83333333333333</c:v>
                </c:pt>
                <c:pt idx="5">
                  <c:v>13.0</c:v>
                </c:pt>
                <c:pt idx="6">
                  <c:v>15.83333333333333</c:v>
                </c:pt>
                <c:pt idx="7">
                  <c:v>17.83333333333328</c:v>
                </c:pt>
                <c:pt idx="8">
                  <c:v>21.33333333333329</c:v>
                </c:pt>
                <c:pt idx="9">
                  <c:v>23.33333333333329</c:v>
                </c:pt>
                <c:pt idx="10">
                  <c:v>30.33333333333329</c:v>
                </c:pt>
                <c:pt idx="11">
                  <c:v>33.33333333333333</c:v>
                </c:pt>
                <c:pt idx="12">
                  <c:v>38.83333333333334</c:v>
                </c:pt>
                <c:pt idx="13">
                  <c:v>43.66666666666659</c:v>
                </c:pt>
              </c:numCache>
            </c:numRef>
          </c:xVal>
          <c:yVal>
            <c:numRef>
              <c:f>'Zm in NAC-2010-ASGH'!$L$24:$L$37</c:f>
              <c:numCache>
                <c:formatCode>0.00</c:formatCode>
                <c:ptCount val="14"/>
                <c:pt idx="0">
                  <c:v>63.41666666666658</c:v>
                </c:pt>
                <c:pt idx="1">
                  <c:v>58.3</c:v>
                </c:pt>
                <c:pt idx="2">
                  <c:v>52.31666666666656</c:v>
                </c:pt>
                <c:pt idx="3">
                  <c:v>35.68333333333333</c:v>
                </c:pt>
                <c:pt idx="4">
                  <c:v>11.605</c:v>
                </c:pt>
                <c:pt idx="5">
                  <c:v>0.358833333333333</c:v>
                </c:pt>
                <c:pt idx="6">
                  <c:v>0.260666666666667</c:v>
                </c:pt>
                <c:pt idx="7">
                  <c:v>0.189166666666667</c:v>
                </c:pt>
                <c:pt idx="8">
                  <c:v>0.0920666666666666</c:v>
                </c:pt>
                <c:pt idx="9">
                  <c:v>0.0623666666666666</c:v>
                </c:pt>
                <c:pt idx="10">
                  <c:v>0.00369666666666667</c:v>
                </c:pt>
                <c:pt idx="11">
                  <c:v>0.00353666666666667</c:v>
                </c:pt>
                <c:pt idx="12">
                  <c:v>0.0</c:v>
                </c:pt>
                <c:pt idx="13">
                  <c:v>0.0</c:v>
                </c:pt>
              </c:numCache>
            </c:numRef>
          </c:yVal>
          <c:smooth val="0"/>
        </c:ser>
        <c:ser>
          <c:idx val="7"/>
          <c:order val="4"/>
          <c:tx>
            <c:strRef>
              <c:f>'Zm in NAC-2010-ASGH'!$M$22:$M$23</c:f>
              <c:strCache>
                <c:ptCount val="1"/>
                <c:pt idx="0">
                  <c:v>NAC-ASGH Xyl (g/l)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squar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0-ASGH'!$R$24:$R$37</c:f>
                <c:numCache>
                  <c:formatCode>General</c:formatCode>
                  <c:ptCount val="14"/>
                  <c:pt idx="0">
                    <c:v>1.66</c:v>
                  </c:pt>
                  <c:pt idx="1">
                    <c:v>1.82</c:v>
                  </c:pt>
                  <c:pt idx="2">
                    <c:v>1.83</c:v>
                  </c:pt>
                  <c:pt idx="3">
                    <c:v>1.86</c:v>
                  </c:pt>
                  <c:pt idx="4">
                    <c:v>1.89</c:v>
                  </c:pt>
                  <c:pt idx="5">
                    <c:v>1.9</c:v>
                  </c:pt>
                  <c:pt idx="6">
                    <c:v>1.88</c:v>
                  </c:pt>
                  <c:pt idx="7">
                    <c:v>2.23</c:v>
                  </c:pt>
                  <c:pt idx="8">
                    <c:v>2.69</c:v>
                  </c:pt>
                  <c:pt idx="9">
                    <c:v>2.98</c:v>
                  </c:pt>
                  <c:pt idx="10">
                    <c:v>3.5</c:v>
                  </c:pt>
                  <c:pt idx="11">
                    <c:v>3.31</c:v>
                  </c:pt>
                  <c:pt idx="12">
                    <c:v>4.359999999999998</c:v>
                  </c:pt>
                  <c:pt idx="13">
                    <c:v>4.18</c:v>
                  </c:pt>
                </c:numCache>
              </c:numRef>
            </c:plus>
            <c:minus>
              <c:numRef>
                <c:f>'Zm in NAC-2010-ASGH'!$R$24:$R$37</c:f>
                <c:numCache>
                  <c:formatCode>General</c:formatCode>
                  <c:ptCount val="14"/>
                  <c:pt idx="0">
                    <c:v>1.66</c:v>
                  </c:pt>
                  <c:pt idx="1">
                    <c:v>1.82</c:v>
                  </c:pt>
                  <c:pt idx="2">
                    <c:v>1.83</c:v>
                  </c:pt>
                  <c:pt idx="3">
                    <c:v>1.86</c:v>
                  </c:pt>
                  <c:pt idx="4">
                    <c:v>1.89</c:v>
                  </c:pt>
                  <c:pt idx="5">
                    <c:v>1.9</c:v>
                  </c:pt>
                  <c:pt idx="6">
                    <c:v>1.88</c:v>
                  </c:pt>
                  <c:pt idx="7">
                    <c:v>2.23</c:v>
                  </c:pt>
                  <c:pt idx="8">
                    <c:v>2.69</c:v>
                  </c:pt>
                  <c:pt idx="9">
                    <c:v>2.98</c:v>
                  </c:pt>
                  <c:pt idx="10">
                    <c:v>3.5</c:v>
                  </c:pt>
                  <c:pt idx="11">
                    <c:v>3.31</c:v>
                  </c:pt>
                  <c:pt idx="12">
                    <c:v>4.359999999999998</c:v>
                  </c:pt>
                  <c:pt idx="13">
                    <c:v>4.18</c:v>
                  </c:pt>
                </c:numCache>
              </c:numRef>
            </c:minus>
          </c:errBars>
          <c:xVal>
            <c:numRef>
              <c:f>'Zm in NAC-2010-ASGH'!$B$24:$B$37</c:f>
              <c:numCache>
                <c:formatCode>0.0</c:formatCode>
                <c:ptCount val="14"/>
                <c:pt idx="0">
                  <c:v>0.0</c:v>
                </c:pt>
                <c:pt idx="1">
                  <c:v>3.333333333333333</c:v>
                </c:pt>
                <c:pt idx="2">
                  <c:v>5.333333333333332</c:v>
                </c:pt>
                <c:pt idx="3">
                  <c:v>8.333333333333332</c:v>
                </c:pt>
                <c:pt idx="4">
                  <c:v>10.83333333333333</c:v>
                </c:pt>
                <c:pt idx="5">
                  <c:v>13.0</c:v>
                </c:pt>
                <c:pt idx="6">
                  <c:v>15.83333333333333</c:v>
                </c:pt>
                <c:pt idx="7">
                  <c:v>17.83333333333328</c:v>
                </c:pt>
                <c:pt idx="8">
                  <c:v>21.33333333333329</c:v>
                </c:pt>
                <c:pt idx="9">
                  <c:v>23.33333333333329</c:v>
                </c:pt>
                <c:pt idx="10">
                  <c:v>30.33333333333329</c:v>
                </c:pt>
                <c:pt idx="11">
                  <c:v>33.33333333333333</c:v>
                </c:pt>
                <c:pt idx="12">
                  <c:v>38.83333333333334</c:v>
                </c:pt>
                <c:pt idx="13">
                  <c:v>43.66666666666659</c:v>
                </c:pt>
              </c:numCache>
            </c:numRef>
          </c:xVal>
          <c:yVal>
            <c:numRef>
              <c:f>'Zm in NAC-2010-ASGH'!$M$24:$M$37</c:f>
              <c:numCache>
                <c:formatCode>0.00</c:formatCode>
                <c:ptCount val="14"/>
                <c:pt idx="0">
                  <c:v>32.48333333333333</c:v>
                </c:pt>
                <c:pt idx="1">
                  <c:v>32.68333333333333</c:v>
                </c:pt>
                <c:pt idx="2">
                  <c:v>32.33333333333334</c:v>
                </c:pt>
                <c:pt idx="3">
                  <c:v>32.31666666666658</c:v>
                </c:pt>
                <c:pt idx="4">
                  <c:v>30.63333333333332</c:v>
                </c:pt>
                <c:pt idx="5">
                  <c:v>27.36666666666666</c:v>
                </c:pt>
                <c:pt idx="6">
                  <c:v>21.08333333333329</c:v>
                </c:pt>
                <c:pt idx="7">
                  <c:v>17.08333333333329</c:v>
                </c:pt>
                <c:pt idx="8">
                  <c:v>12.73333333333333</c:v>
                </c:pt>
                <c:pt idx="9">
                  <c:v>11.55833333333333</c:v>
                </c:pt>
                <c:pt idx="10">
                  <c:v>7.541666666666666</c:v>
                </c:pt>
                <c:pt idx="11">
                  <c:v>6.836666666666665</c:v>
                </c:pt>
                <c:pt idx="12">
                  <c:v>5.93166666666667</c:v>
                </c:pt>
                <c:pt idx="13">
                  <c:v>5.548333333333332</c:v>
                </c:pt>
              </c:numCache>
            </c:numRef>
          </c:yVal>
          <c:smooth val="0"/>
        </c:ser>
        <c:ser>
          <c:idx val="8"/>
          <c:order val="5"/>
          <c:tx>
            <c:strRef>
              <c:f>'Zm in NAC-2010-ASGH'!$O$22:$O$23</c:f>
              <c:strCache>
                <c:ptCount val="1"/>
                <c:pt idx="0">
                  <c:v>NAC-ASGH EtOH (g/l)</c:v>
                </c:pt>
              </c:strCache>
            </c:strRef>
          </c:tx>
          <c:spPr>
            <a:ln>
              <a:solidFill>
                <a:schemeClr val="accent5"/>
              </a:solidFill>
            </a:ln>
          </c:spPr>
          <c:marker>
            <c:symbol val="triangle"/>
            <c:size val="9"/>
            <c:spPr>
              <a:solidFill>
                <a:schemeClr val="accent5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0-ASGH'!$S$24:$S$37</c:f>
                <c:numCache>
                  <c:formatCode>General</c:formatCode>
                  <c:ptCount val="14"/>
                  <c:pt idx="0">
                    <c:v>0.02</c:v>
                  </c:pt>
                  <c:pt idx="1">
                    <c:v>0.15</c:v>
                  </c:pt>
                  <c:pt idx="2">
                    <c:v>0.33</c:v>
                  </c:pt>
                  <c:pt idx="3">
                    <c:v>0.7</c:v>
                  </c:pt>
                  <c:pt idx="4">
                    <c:v>0.89</c:v>
                  </c:pt>
                  <c:pt idx="5">
                    <c:v>1.16</c:v>
                  </c:pt>
                  <c:pt idx="6">
                    <c:v>0.08</c:v>
                  </c:pt>
                  <c:pt idx="7">
                    <c:v>0.38</c:v>
                  </c:pt>
                  <c:pt idx="8">
                    <c:v>0.72</c:v>
                  </c:pt>
                  <c:pt idx="9">
                    <c:v>0.71</c:v>
                  </c:pt>
                  <c:pt idx="10">
                    <c:v>0.84</c:v>
                  </c:pt>
                  <c:pt idx="11">
                    <c:v>1.03</c:v>
                  </c:pt>
                  <c:pt idx="12">
                    <c:v>1.06</c:v>
                  </c:pt>
                  <c:pt idx="13">
                    <c:v>0.92</c:v>
                  </c:pt>
                </c:numCache>
              </c:numRef>
            </c:plus>
            <c:minus>
              <c:numRef>
                <c:f>'Zm in NAC-2010-ASGH'!$S$24:$S$37</c:f>
                <c:numCache>
                  <c:formatCode>General</c:formatCode>
                  <c:ptCount val="14"/>
                  <c:pt idx="0">
                    <c:v>0.02</c:v>
                  </c:pt>
                  <c:pt idx="1">
                    <c:v>0.15</c:v>
                  </c:pt>
                  <c:pt idx="2">
                    <c:v>0.33</c:v>
                  </c:pt>
                  <c:pt idx="3">
                    <c:v>0.7</c:v>
                  </c:pt>
                  <c:pt idx="4">
                    <c:v>0.89</c:v>
                  </c:pt>
                  <c:pt idx="5">
                    <c:v>1.16</c:v>
                  </c:pt>
                  <c:pt idx="6">
                    <c:v>0.08</c:v>
                  </c:pt>
                  <c:pt idx="7">
                    <c:v>0.38</c:v>
                  </c:pt>
                  <c:pt idx="8">
                    <c:v>0.72</c:v>
                  </c:pt>
                  <c:pt idx="9">
                    <c:v>0.71</c:v>
                  </c:pt>
                  <c:pt idx="10">
                    <c:v>0.84</c:v>
                  </c:pt>
                  <c:pt idx="11">
                    <c:v>1.03</c:v>
                  </c:pt>
                  <c:pt idx="12">
                    <c:v>1.06</c:v>
                  </c:pt>
                  <c:pt idx="13">
                    <c:v>0.92</c:v>
                  </c:pt>
                </c:numCache>
              </c:numRef>
            </c:minus>
          </c:errBars>
          <c:xVal>
            <c:numRef>
              <c:f>'Zm in NAC-2010-ASGH'!$B$24:$B$37</c:f>
              <c:numCache>
                <c:formatCode>0.0</c:formatCode>
                <c:ptCount val="14"/>
                <c:pt idx="0">
                  <c:v>0.0</c:v>
                </c:pt>
                <c:pt idx="1">
                  <c:v>3.333333333333333</c:v>
                </c:pt>
                <c:pt idx="2">
                  <c:v>5.333333333333332</c:v>
                </c:pt>
                <c:pt idx="3">
                  <c:v>8.333333333333332</c:v>
                </c:pt>
                <c:pt idx="4">
                  <c:v>10.83333333333333</c:v>
                </c:pt>
                <c:pt idx="5">
                  <c:v>13.0</c:v>
                </c:pt>
                <c:pt idx="6">
                  <c:v>15.83333333333333</c:v>
                </c:pt>
                <c:pt idx="7">
                  <c:v>17.83333333333328</c:v>
                </c:pt>
                <c:pt idx="8">
                  <c:v>21.33333333333329</c:v>
                </c:pt>
                <c:pt idx="9">
                  <c:v>23.33333333333329</c:v>
                </c:pt>
                <c:pt idx="10">
                  <c:v>30.33333333333329</c:v>
                </c:pt>
                <c:pt idx="11">
                  <c:v>33.33333333333333</c:v>
                </c:pt>
                <c:pt idx="12">
                  <c:v>38.83333333333334</c:v>
                </c:pt>
                <c:pt idx="13">
                  <c:v>43.66666666666659</c:v>
                </c:pt>
              </c:numCache>
            </c:numRef>
          </c:xVal>
          <c:yVal>
            <c:numRef>
              <c:f>'Zm in NAC-2010-ASGH'!$O$24:$O$37</c:f>
              <c:numCache>
                <c:formatCode>0.00</c:formatCode>
                <c:ptCount val="14"/>
                <c:pt idx="0">
                  <c:v>0.0180492</c:v>
                </c:pt>
                <c:pt idx="1">
                  <c:v>2.868666666666667</c:v>
                </c:pt>
                <c:pt idx="2">
                  <c:v>6.139466666666667</c:v>
                </c:pt>
                <c:pt idx="3">
                  <c:v>13.052</c:v>
                </c:pt>
                <c:pt idx="4">
                  <c:v>24.284</c:v>
                </c:pt>
                <c:pt idx="5">
                  <c:v>31.616</c:v>
                </c:pt>
                <c:pt idx="6">
                  <c:v>33.08</c:v>
                </c:pt>
                <c:pt idx="7">
                  <c:v>34.76</c:v>
                </c:pt>
                <c:pt idx="8">
                  <c:v>36.43333333333334</c:v>
                </c:pt>
                <c:pt idx="9">
                  <c:v>36.74666666666659</c:v>
                </c:pt>
                <c:pt idx="10">
                  <c:v>37.74333333333333</c:v>
                </c:pt>
                <c:pt idx="11">
                  <c:v>37.83</c:v>
                </c:pt>
                <c:pt idx="12">
                  <c:v>37.83333333333333</c:v>
                </c:pt>
                <c:pt idx="13">
                  <c:v>37.44333333333333</c:v>
                </c:pt>
              </c:numCache>
            </c:numRef>
          </c:yVal>
          <c:smooth val="0"/>
        </c:ser>
        <c:ser>
          <c:idx val="3"/>
          <c:order val="0"/>
          <c:tx>
            <c:strRef>
              <c:f>'Zm in NAC-2012-ACSH'!$L$21:$L$22</c:f>
              <c:strCache>
                <c:ptCount val="1"/>
                <c:pt idx="0">
                  <c:v>NAC-ACSH Glu (g/l)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circl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2-ACSH'!$Q$23:$Q$36</c:f>
                <c:numCache>
                  <c:formatCode>General</c:formatCode>
                  <c:ptCount val="14"/>
                  <c:pt idx="0">
                    <c:v>1.69</c:v>
                  </c:pt>
                  <c:pt idx="1">
                    <c:v>2.02</c:v>
                  </c:pt>
                  <c:pt idx="2">
                    <c:v>2.37</c:v>
                  </c:pt>
                  <c:pt idx="3">
                    <c:v>2.95</c:v>
                  </c:pt>
                  <c:pt idx="4">
                    <c:v>3.33</c:v>
                  </c:pt>
                  <c:pt idx="5">
                    <c:v>3.33</c:v>
                  </c:pt>
                  <c:pt idx="6">
                    <c:v>1.3</c:v>
                  </c:pt>
                  <c:pt idx="7">
                    <c:v>0.71</c:v>
                  </c:pt>
                  <c:pt idx="8">
                    <c:v>0.05</c:v>
                  </c:pt>
                  <c:pt idx="9">
                    <c:v>0.03</c:v>
                  </c:pt>
                  <c:pt idx="10">
                    <c:v>0.04</c:v>
                  </c:pt>
                  <c:pt idx="11">
                    <c:v>0.09</c:v>
                  </c:pt>
                  <c:pt idx="12">
                    <c:v>0.08</c:v>
                  </c:pt>
                  <c:pt idx="13">
                    <c:v>0.05</c:v>
                  </c:pt>
                </c:numCache>
              </c:numRef>
            </c:plus>
            <c:minus>
              <c:numRef>
                <c:f>'Zm in NAC-2012-ACSH'!$Q$23:$Q$36</c:f>
                <c:numCache>
                  <c:formatCode>General</c:formatCode>
                  <c:ptCount val="14"/>
                  <c:pt idx="0">
                    <c:v>1.69</c:v>
                  </c:pt>
                  <c:pt idx="1">
                    <c:v>2.02</c:v>
                  </c:pt>
                  <c:pt idx="2">
                    <c:v>2.37</c:v>
                  </c:pt>
                  <c:pt idx="3">
                    <c:v>2.95</c:v>
                  </c:pt>
                  <c:pt idx="4">
                    <c:v>3.33</c:v>
                  </c:pt>
                  <c:pt idx="5">
                    <c:v>3.33</c:v>
                  </c:pt>
                  <c:pt idx="6">
                    <c:v>1.3</c:v>
                  </c:pt>
                  <c:pt idx="7">
                    <c:v>0.71</c:v>
                  </c:pt>
                  <c:pt idx="8">
                    <c:v>0.05</c:v>
                  </c:pt>
                  <c:pt idx="9">
                    <c:v>0.03</c:v>
                  </c:pt>
                  <c:pt idx="10">
                    <c:v>0.04</c:v>
                  </c:pt>
                  <c:pt idx="11">
                    <c:v>0.09</c:v>
                  </c:pt>
                  <c:pt idx="12">
                    <c:v>0.08</c:v>
                  </c:pt>
                  <c:pt idx="13">
                    <c:v>0.05</c:v>
                  </c:pt>
                </c:numCache>
              </c:numRef>
            </c:minus>
          </c:errBars>
          <c:xVal>
            <c:numRef>
              <c:f>'Zm in NAC-2012-ACSH'!$B$23:$B$36</c:f>
              <c:numCache>
                <c:formatCode>0.0</c:formatCode>
                <c:ptCount val="14"/>
                <c:pt idx="0">
                  <c:v>0.0</c:v>
                </c:pt>
                <c:pt idx="1">
                  <c:v>1.999999999999998</c:v>
                </c:pt>
                <c:pt idx="2">
                  <c:v>3.999999999999999</c:v>
                </c:pt>
                <c:pt idx="3">
                  <c:v>6.0</c:v>
                </c:pt>
                <c:pt idx="4">
                  <c:v>7.999999999999998</c:v>
                </c:pt>
                <c:pt idx="5">
                  <c:v>10.0</c:v>
                </c:pt>
                <c:pt idx="6">
                  <c:v>10.33333333333333</c:v>
                </c:pt>
                <c:pt idx="7">
                  <c:v>13.0</c:v>
                </c:pt>
                <c:pt idx="8">
                  <c:v>16.0</c:v>
                </c:pt>
                <c:pt idx="9">
                  <c:v>18.0</c:v>
                </c:pt>
                <c:pt idx="10">
                  <c:v>20.7</c:v>
                </c:pt>
                <c:pt idx="11">
                  <c:v>26.0</c:v>
                </c:pt>
                <c:pt idx="12">
                  <c:v>34.42</c:v>
                </c:pt>
                <c:pt idx="13">
                  <c:v>40.0</c:v>
                </c:pt>
              </c:numCache>
            </c:numRef>
          </c:xVal>
          <c:yVal>
            <c:numRef>
              <c:f>'Zm in NAC-2012-ACSH'!$L$23:$L$36</c:f>
              <c:numCache>
                <c:formatCode>0.00</c:formatCode>
                <c:ptCount val="14"/>
                <c:pt idx="0">
                  <c:v>70.06666666666666</c:v>
                </c:pt>
                <c:pt idx="1">
                  <c:v>65.76666666666666</c:v>
                </c:pt>
                <c:pt idx="2">
                  <c:v>60.16666666666659</c:v>
                </c:pt>
                <c:pt idx="3">
                  <c:v>51.85</c:v>
                </c:pt>
                <c:pt idx="4">
                  <c:v>36.91666666666658</c:v>
                </c:pt>
                <c:pt idx="5">
                  <c:v>18.86666666666667</c:v>
                </c:pt>
                <c:pt idx="6">
                  <c:v>11.58</c:v>
                </c:pt>
                <c:pt idx="7">
                  <c:v>0.451333333333333</c:v>
                </c:pt>
                <c:pt idx="8">
                  <c:v>0.319833333333333</c:v>
                </c:pt>
                <c:pt idx="9">
                  <c:v>0.191383333333333</c:v>
                </c:pt>
                <c:pt idx="10">
                  <c:v>0.22</c:v>
                </c:pt>
                <c:pt idx="11">
                  <c:v>0.10795</c:v>
                </c:pt>
                <c:pt idx="12">
                  <c:v>0.0321333333333333</c:v>
                </c:pt>
                <c:pt idx="13">
                  <c:v>0.0316166666666667</c:v>
                </c:pt>
              </c:numCache>
            </c:numRef>
          </c:yVal>
          <c:smooth val="0"/>
        </c:ser>
        <c:ser>
          <c:idx val="4"/>
          <c:order val="1"/>
          <c:tx>
            <c:strRef>
              <c:f>'Zm in NAC-2012-ACSH'!$M$21:$M$22</c:f>
              <c:strCache>
                <c:ptCount val="1"/>
                <c:pt idx="0">
                  <c:v>NAC-ACSH Xyl (g/l)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squar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2-ACSH'!$R$23:$R$36</c:f>
                <c:numCache>
                  <c:formatCode>General</c:formatCode>
                  <c:ptCount val="14"/>
                  <c:pt idx="0">
                    <c:v>1.66</c:v>
                  </c:pt>
                  <c:pt idx="1">
                    <c:v>1.82</c:v>
                  </c:pt>
                  <c:pt idx="2">
                    <c:v>1.83</c:v>
                  </c:pt>
                  <c:pt idx="3">
                    <c:v>1.86</c:v>
                  </c:pt>
                  <c:pt idx="4">
                    <c:v>1.89</c:v>
                  </c:pt>
                  <c:pt idx="5">
                    <c:v>1.9</c:v>
                  </c:pt>
                  <c:pt idx="6">
                    <c:v>1.88</c:v>
                  </c:pt>
                  <c:pt idx="7">
                    <c:v>2.23</c:v>
                  </c:pt>
                  <c:pt idx="8">
                    <c:v>2.69</c:v>
                  </c:pt>
                  <c:pt idx="9">
                    <c:v>2.98</c:v>
                  </c:pt>
                  <c:pt idx="10">
                    <c:v>3.5</c:v>
                  </c:pt>
                  <c:pt idx="11">
                    <c:v>3.31</c:v>
                  </c:pt>
                  <c:pt idx="12">
                    <c:v>4.359999999999998</c:v>
                  </c:pt>
                  <c:pt idx="13">
                    <c:v>4.18</c:v>
                  </c:pt>
                </c:numCache>
              </c:numRef>
            </c:plus>
            <c:minus>
              <c:numRef>
                <c:f>'Zm in NAC-2012-ACSH'!$R$23:$R$36</c:f>
                <c:numCache>
                  <c:formatCode>General</c:formatCode>
                  <c:ptCount val="14"/>
                  <c:pt idx="0">
                    <c:v>1.66</c:v>
                  </c:pt>
                  <c:pt idx="1">
                    <c:v>1.82</c:v>
                  </c:pt>
                  <c:pt idx="2">
                    <c:v>1.83</c:v>
                  </c:pt>
                  <c:pt idx="3">
                    <c:v>1.86</c:v>
                  </c:pt>
                  <c:pt idx="4">
                    <c:v>1.89</c:v>
                  </c:pt>
                  <c:pt idx="5">
                    <c:v>1.9</c:v>
                  </c:pt>
                  <c:pt idx="6">
                    <c:v>1.88</c:v>
                  </c:pt>
                  <c:pt idx="7">
                    <c:v>2.23</c:v>
                  </c:pt>
                  <c:pt idx="8">
                    <c:v>2.69</c:v>
                  </c:pt>
                  <c:pt idx="9">
                    <c:v>2.98</c:v>
                  </c:pt>
                  <c:pt idx="10">
                    <c:v>3.5</c:v>
                  </c:pt>
                  <c:pt idx="11">
                    <c:v>3.31</c:v>
                  </c:pt>
                  <c:pt idx="12">
                    <c:v>4.359999999999998</c:v>
                  </c:pt>
                  <c:pt idx="13">
                    <c:v>4.18</c:v>
                  </c:pt>
                </c:numCache>
              </c:numRef>
            </c:minus>
          </c:errBars>
          <c:xVal>
            <c:numRef>
              <c:f>'Zm in NAC-2012-ACSH'!$B$23:$B$36</c:f>
              <c:numCache>
                <c:formatCode>0.0</c:formatCode>
                <c:ptCount val="14"/>
                <c:pt idx="0">
                  <c:v>0.0</c:v>
                </c:pt>
                <c:pt idx="1">
                  <c:v>1.999999999999998</c:v>
                </c:pt>
                <c:pt idx="2">
                  <c:v>3.999999999999999</c:v>
                </c:pt>
                <c:pt idx="3">
                  <c:v>6.0</c:v>
                </c:pt>
                <c:pt idx="4">
                  <c:v>7.999999999999998</c:v>
                </c:pt>
                <c:pt idx="5">
                  <c:v>10.0</c:v>
                </c:pt>
                <c:pt idx="6">
                  <c:v>10.33333333333333</c:v>
                </c:pt>
                <c:pt idx="7">
                  <c:v>13.0</c:v>
                </c:pt>
                <c:pt idx="8">
                  <c:v>16.0</c:v>
                </c:pt>
                <c:pt idx="9">
                  <c:v>18.0</c:v>
                </c:pt>
                <c:pt idx="10">
                  <c:v>20.7</c:v>
                </c:pt>
                <c:pt idx="11">
                  <c:v>26.0</c:v>
                </c:pt>
                <c:pt idx="12">
                  <c:v>34.42</c:v>
                </c:pt>
                <c:pt idx="13">
                  <c:v>40.0</c:v>
                </c:pt>
              </c:numCache>
            </c:numRef>
          </c:xVal>
          <c:yVal>
            <c:numRef>
              <c:f>'Zm in NAC-2012-ACSH'!$M$23:$M$36</c:f>
              <c:numCache>
                <c:formatCode>0.00</c:formatCode>
                <c:ptCount val="14"/>
                <c:pt idx="0">
                  <c:v>30.2</c:v>
                </c:pt>
                <c:pt idx="1">
                  <c:v>30.11666666666666</c:v>
                </c:pt>
                <c:pt idx="2">
                  <c:v>30.1833333333333</c:v>
                </c:pt>
                <c:pt idx="3">
                  <c:v>29.91666666666667</c:v>
                </c:pt>
                <c:pt idx="4">
                  <c:v>29.61666666666666</c:v>
                </c:pt>
                <c:pt idx="5">
                  <c:v>28.91666666666667</c:v>
                </c:pt>
                <c:pt idx="6">
                  <c:v>28.46666666666667</c:v>
                </c:pt>
                <c:pt idx="7">
                  <c:v>24.63333333333332</c:v>
                </c:pt>
                <c:pt idx="8">
                  <c:v>19.95</c:v>
                </c:pt>
                <c:pt idx="9">
                  <c:v>16.51666666666667</c:v>
                </c:pt>
                <c:pt idx="10">
                  <c:v>14.7</c:v>
                </c:pt>
                <c:pt idx="11">
                  <c:v>10.84833333333333</c:v>
                </c:pt>
                <c:pt idx="12">
                  <c:v>8.28</c:v>
                </c:pt>
                <c:pt idx="13">
                  <c:v>7.826666666666667</c:v>
                </c:pt>
              </c:numCache>
            </c:numRef>
          </c:yVal>
          <c:smooth val="0"/>
        </c:ser>
        <c:ser>
          <c:idx val="5"/>
          <c:order val="2"/>
          <c:tx>
            <c:strRef>
              <c:f>'Zm in NAC-2012-ACSH'!$O$21:$O$22</c:f>
              <c:strCache>
                <c:ptCount val="1"/>
                <c:pt idx="0">
                  <c:v>NAC-ACSH EtOH (g/l)</c:v>
                </c:pt>
              </c:strCache>
            </c:strRef>
          </c:tx>
          <c:spPr>
            <a:ln>
              <a:solidFill>
                <a:schemeClr val="accent2"/>
              </a:solidFill>
            </a:ln>
          </c:spPr>
          <c:marker>
            <c:symbol val="triangle"/>
            <c:size val="9"/>
            <c:spPr>
              <a:solidFill>
                <a:schemeClr val="accent2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Zm in NAC-2012-ACSH'!$S$23:$S$36</c:f>
                <c:numCache>
                  <c:formatCode>General</c:formatCode>
                  <c:ptCount val="14"/>
                  <c:pt idx="0">
                    <c:v>0.02</c:v>
                  </c:pt>
                  <c:pt idx="1">
                    <c:v>0.15</c:v>
                  </c:pt>
                  <c:pt idx="2">
                    <c:v>0.33</c:v>
                  </c:pt>
                  <c:pt idx="3">
                    <c:v>0.7</c:v>
                  </c:pt>
                  <c:pt idx="4">
                    <c:v>0.89</c:v>
                  </c:pt>
                  <c:pt idx="5">
                    <c:v>1.16</c:v>
                  </c:pt>
                  <c:pt idx="6">
                    <c:v>0.08</c:v>
                  </c:pt>
                  <c:pt idx="7">
                    <c:v>0.38</c:v>
                  </c:pt>
                  <c:pt idx="8">
                    <c:v>0.72</c:v>
                  </c:pt>
                  <c:pt idx="9">
                    <c:v>0.71</c:v>
                  </c:pt>
                  <c:pt idx="10">
                    <c:v>0.84</c:v>
                  </c:pt>
                  <c:pt idx="11">
                    <c:v>1.03</c:v>
                  </c:pt>
                  <c:pt idx="12">
                    <c:v>1.06</c:v>
                  </c:pt>
                  <c:pt idx="13">
                    <c:v>0.92</c:v>
                  </c:pt>
                </c:numCache>
              </c:numRef>
            </c:plus>
            <c:minus>
              <c:numRef>
                <c:f>'Zm in NAC-2012-ACSH'!$S$23:$S$36</c:f>
                <c:numCache>
                  <c:formatCode>General</c:formatCode>
                  <c:ptCount val="14"/>
                  <c:pt idx="0">
                    <c:v>0.02</c:v>
                  </c:pt>
                  <c:pt idx="1">
                    <c:v>0.15</c:v>
                  </c:pt>
                  <c:pt idx="2">
                    <c:v>0.33</c:v>
                  </c:pt>
                  <c:pt idx="3">
                    <c:v>0.7</c:v>
                  </c:pt>
                  <c:pt idx="4">
                    <c:v>0.89</c:v>
                  </c:pt>
                  <c:pt idx="5">
                    <c:v>1.16</c:v>
                  </c:pt>
                  <c:pt idx="6">
                    <c:v>0.08</c:v>
                  </c:pt>
                  <c:pt idx="7">
                    <c:v>0.38</c:v>
                  </c:pt>
                  <c:pt idx="8">
                    <c:v>0.72</c:v>
                  </c:pt>
                  <c:pt idx="9">
                    <c:v>0.71</c:v>
                  </c:pt>
                  <c:pt idx="10">
                    <c:v>0.84</c:v>
                  </c:pt>
                  <c:pt idx="11">
                    <c:v>1.03</c:v>
                  </c:pt>
                  <c:pt idx="12">
                    <c:v>1.06</c:v>
                  </c:pt>
                  <c:pt idx="13">
                    <c:v>0.92</c:v>
                  </c:pt>
                </c:numCache>
              </c:numRef>
            </c:minus>
          </c:errBars>
          <c:xVal>
            <c:numRef>
              <c:f>'Zm in NAC-2012-ACSH'!$B$23:$B$36</c:f>
              <c:numCache>
                <c:formatCode>0.0</c:formatCode>
                <c:ptCount val="14"/>
                <c:pt idx="0">
                  <c:v>0.0</c:v>
                </c:pt>
                <c:pt idx="1">
                  <c:v>1.999999999999998</c:v>
                </c:pt>
                <c:pt idx="2">
                  <c:v>3.999999999999999</c:v>
                </c:pt>
                <c:pt idx="3">
                  <c:v>6.0</c:v>
                </c:pt>
                <c:pt idx="4">
                  <c:v>7.999999999999998</c:v>
                </c:pt>
                <c:pt idx="5">
                  <c:v>10.0</c:v>
                </c:pt>
                <c:pt idx="6">
                  <c:v>10.33333333333333</c:v>
                </c:pt>
                <c:pt idx="7">
                  <c:v>13.0</c:v>
                </c:pt>
                <c:pt idx="8">
                  <c:v>16.0</c:v>
                </c:pt>
                <c:pt idx="9">
                  <c:v>18.0</c:v>
                </c:pt>
                <c:pt idx="10">
                  <c:v>20.7</c:v>
                </c:pt>
                <c:pt idx="11">
                  <c:v>26.0</c:v>
                </c:pt>
                <c:pt idx="12">
                  <c:v>34.42</c:v>
                </c:pt>
                <c:pt idx="13">
                  <c:v>40.0</c:v>
                </c:pt>
              </c:numCache>
            </c:numRef>
          </c:xVal>
          <c:yVal>
            <c:numRef>
              <c:f>'Zm in NAC-2012-ACSH'!$O$23:$O$36</c:f>
              <c:numCache>
                <c:formatCode>0.00</c:formatCode>
                <c:ptCount val="14"/>
                <c:pt idx="0">
                  <c:v>0.041973</c:v>
                </c:pt>
                <c:pt idx="1">
                  <c:v>1.7986</c:v>
                </c:pt>
                <c:pt idx="2">
                  <c:v>4.3588</c:v>
                </c:pt>
                <c:pt idx="3">
                  <c:v>7.7418</c:v>
                </c:pt>
                <c:pt idx="4">
                  <c:v>14.093</c:v>
                </c:pt>
                <c:pt idx="5">
                  <c:v>22.117</c:v>
                </c:pt>
                <c:pt idx="6">
                  <c:v>25.76</c:v>
                </c:pt>
                <c:pt idx="7">
                  <c:v>33.03333333333333</c:v>
                </c:pt>
                <c:pt idx="8">
                  <c:v>34.9866666666666</c:v>
                </c:pt>
                <c:pt idx="9">
                  <c:v>35.90000000000001</c:v>
                </c:pt>
                <c:pt idx="10">
                  <c:v>36.818</c:v>
                </c:pt>
                <c:pt idx="11">
                  <c:v>37.28666666666659</c:v>
                </c:pt>
                <c:pt idx="12">
                  <c:v>37.08280000000001</c:v>
                </c:pt>
                <c:pt idx="13">
                  <c:v>36.4133333333333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35424392"/>
        <c:axId val="-2035418872"/>
      </c:scatterChart>
      <c:valAx>
        <c:axId val="-2035424392"/>
        <c:scaling>
          <c:orientation val="minMax"/>
          <c:max val="60.0"/>
          <c:min val="0.0"/>
        </c:scaling>
        <c:delete val="0"/>
        <c:axPos val="b"/>
        <c:title>
          <c:tx>
            <c:rich>
              <a:bodyPr/>
              <a:lstStyle/>
              <a:p>
                <a:pPr>
                  <a:defRPr sz="1600"/>
                </a:pPr>
                <a:r>
                  <a:rPr lang="en-US" sz="1600"/>
                  <a:t>Time (h)</a:t>
                </a:r>
              </a:p>
            </c:rich>
          </c:tx>
          <c:layout>
            <c:manualLayout>
              <c:xMode val="edge"/>
              <c:yMode val="edge"/>
              <c:x val="0.423292962091079"/>
              <c:y val="0.9283747641049"/>
            </c:manualLayout>
          </c:layout>
          <c:overlay val="0"/>
        </c:title>
        <c:numFmt formatCode="0" sourceLinked="0"/>
        <c:majorTickMark val="out"/>
        <c:minorTickMark val="in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-2035418872"/>
        <c:crosses val="autoZero"/>
        <c:crossBetween val="midCat"/>
      </c:valAx>
      <c:valAx>
        <c:axId val="-2035418872"/>
        <c:scaling>
          <c:orientation val="minMax"/>
          <c:min val="0.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/>
                  <a:t>Glucose/Xylose/Ethanol (g/l)</a:t>
                </a:r>
              </a:p>
            </c:rich>
          </c:tx>
          <c:layout>
            <c:manualLayout>
              <c:xMode val="edge"/>
              <c:yMode val="edge"/>
              <c:x val="0.0232359703120448"/>
              <c:y val="0.0951035013220826"/>
            </c:manualLayout>
          </c:layout>
          <c:overlay val="0"/>
        </c:title>
        <c:numFmt formatCode="0" sourceLinked="0"/>
        <c:majorTickMark val="out"/>
        <c:minorTickMark val="in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-2035424392"/>
        <c:crosses val="autoZero"/>
        <c:crossBetween val="midCat"/>
        <c:majorUnit val="20.0"/>
      </c:valAx>
    </c:plotArea>
    <c:legend>
      <c:legendPos val="r"/>
      <c:layout>
        <c:manualLayout>
          <c:xMode val="edge"/>
          <c:yMode val="edge"/>
          <c:x val="0.548529142605279"/>
          <c:y val="0.0018339117325844"/>
          <c:w val="0.447552420692424"/>
          <c:h val="0.381222546957612"/>
        </c:manualLayout>
      </c:layout>
      <c:overlay val="0"/>
      <c:spPr>
        <a:solidFill>
          <a:srgbClr val="FFFFFF"/>
        </a:solidFill>
        <a:ln w="9525" cap="flat" cmpd="sng" algn="ctr">
          <a:solidFill>
            <a:srgbClr val="000000"/>
          </a:solidFill>
          <a:prstDash val="solid"/>
        </a:ln>
        <a:effectLst/>
      </c:spPr>
      <c:txPr>
        <a:bodyPr/>
        <a:lstStyle/>
        <a:p>
          <a:pPr>
            <a:defRPr sz="1400">
              <a:solidFill>
                <a:schemeClr val="dk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 w="9525" cap="flat" cmpd="sng" algn="ctr">
      <a:solidFill>
        <a:srgbClr val="000000"/>
      </a:solidFill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3E246D-0DDB-BD41-90BA-03BA39E12C2B}" type="datetimeFigureOut">
              <a:rPr lang="en-US" smtClean="0"/>
              <a:t>8/5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861616-08D1-984A-8E34-EE82F8101B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375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>
              <a:defRPr/>
            </a:pPr>
            <a:r>
              <a:rPr lang="en-US" smtClean="0"/>
              <a:t>www.glbrc.org</a:t>
            </a: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>
              <a:defRPr/>
            </a:pPr>
            <a:fld id="{4A576972-59AE-4849-A42A-0C396822BBB1}" type="slidenum">
              <a:rPr lang="en-US" smtClean="0"/>
              <a:pPr>
                <a:defRPr/>
              </a:pPr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598843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179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374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7507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16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108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551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7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5242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6545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5192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64593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208DE7-1F78-D946-A5D4-5E2580162E38}" type="datetimeFigureOut">
              <a:rPr lang="en-US" smtClean="0"/>
              <a:t>8/5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0108D-2B67-D041-BD4E-33899F456B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95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2524593" y="726827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29" name="TextBox 28"/>
          <p:cNvSpPr txBox="1"/>
          <p:nvPr/>
        </p:nvSpPr>
        <p:spPr>
          <a:xfrm>
            <a:off x="428416" y="6308209"/>
            <a:ext cx="29544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. S2  </a:t>
            </a:r>
            <a:r>
              <a:rPr lang="en-US" dirty="0" err="1" smtClean="0"/>
              <a:t>Zm</a:t>
            </a:r>
            <a:r>
              <a:rPr lang="en-US" dirty="0"/>
              <a:t> </a:t>
            </a:r>
            <a:r>
              <a:rPr lang="en-US" dirty="0" smtClean="0"/>
              <a:t>in ACSH and ASGH</a:t>
            </a:r>
            <a:endParaRPr lang="en-US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2310563"/>
              </p:ext>
            </p:extLst>
          </p:nvPr>
        </p:nvGraphicFramePr>
        <p:xfrm>
          <a:off x="277037" y="1431207"/>
          <a:ext cx="4225746" cy="34581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48473224"/>
              </p:ext>
            </p:extLst>
          </p:nvPr>
        </p:nvGraphicFramePr>
        <p:xfrm>
          <a:off x="4721019" y="1468443"/>
          <a:ext cx="4283488" cy="35050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6356843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</TotalTime>
  <Words>29</Words>
  <Application>Microsoft Macintosh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W Madis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Growth, Sugar Utilization and Ethanol production in Autoclaved and Non-Autoclaved ACSH (Z. mobilis)</dc:title>
  <dc:creator>Yaoping Zhang</dc:creator>
  <cp:lastModifiedBy>Yaoping Zhang</cp:lastModifiedBy>
  <cp:revision>19</cp:revision>
  <cp:lastPrinted>2015-03-23T13:56:06Z</cp:lastPrinted>
  <dcterms:created xsi:type="dcterms:W3CDTF">2015-03-05T06:10:38Z</dcterms:created>
  <dcterms:modified xsi:type="dcterms:W3CDTF">2015-08-05T20:27:26Z</dcterms:modified>
</cp:coreProperties>
</file>